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66" r:id="rId3"/>
    <p:sldId id="267" r:id="rId4"/>
    <p:sldId id="268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6" autoAdjust="0"/>
    <p:restoredTop sz="94660"/>
  </p:normalViewPr>
  <p:slideViewPr>
    <p:cSldViewPr snapToGrid="0">
      <p:cViewPr varScale="1">
        <p:scale>
          <a:sx n="99" d="100"/>
          <a:sy n="99" d="100"/>
        </p:scale>
        <p:origin x="68" y="1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aniel Kerruish" userId="eafcbf4d4b911c7b" providerId="LiveId" clId="{DE883276-5810-43A3-B3BC-FE1D337ABBB8}"/>
    <pc:docChg chg="custSel modSld">
      <pc:chgData name="Daniel Kerruish" userId="eafcbf4d4b911c7b" providerId="LiveId" clId="{DE883276-5810-43A3-B3BC-FE1D337ABBB8}" dt="2025-01-17T13:47:40.656" v="7" actId="255"/>
      <pc:docMkLst>
        <pc:docMk/>
      </pc:docMkLst>
      <pc:sldChg chg="modSp mod">
        <pc:chgData name="Daniel Kerruish" userId="eafcbf4d4b911c7b" providerId="LiveId" clId="{DE883276-5810-43A3-B3BC-FE1D337ABBB8}" dt="2025-01-17T13:47:40.656" v="7" actId="255"/>
        <pc:sldMkLst>
          <pc:docMk/>
          <pc:sldMk cId="3165038675" sldId="268"/>
        </pc:sldMkLst>
        <pc:spChg chg="mod">
          <ac:chgData name="Daniel Kerruish" userId="eafcbf4d4b911c7b" providerId="LiveId" clId="{DE883276-5810-43A3-B3BC-FE1D337ABBB8}" dt="2025-01-17T13:47:40.656" v="7" actId="255"/>
          <ac:spMkLst>
            <pc:docMk/>
            <pc:sldMk cId="3165038675" sldId="268"/>
            <ac:spMk id="3" creationId="{C9E1AD29-C171-2E71-D8DA-B9071BB06082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B076B7-327B-1240-12ED-12BCCA6869F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7683A8E-E777-2FD4-E559-462A84E954F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1C18E0-151A-C397-E3E7-0554DFB388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9C048-5EBA-48FE-B275-9A3CD1A75B26}" type="datetimeFigureOut">
              <a:rPr lang="en-IE" smtClean="0"/>
              <a:t>17/01/2025</a:t>
            </a:fld>
            <a:endParaRPr lang="en-I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8BD842-DDA9-CF55-3578-DA4AA2C10E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576CC6-0291-62AA-784F-17706579B9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17C82-8F7B-4DA2-9C2B-DDD40395D6D5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7783652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ED007A-B641-C918-58A0-B7AEBEB433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24BC7CA-97E2-D08F-8445-EF805F3E6EB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FCDBA8-4865-8D83-4AEB-7E4A8C5786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9C048-5EBA-48FE-B275-9A3CD1A75B26}" type="datetimeFigureOut">
              <a:rPr lang="en-IE" smtClean="0"/>
              <a:t>17/01/2025</a:t>
            </a:fld>
            <a:endParaRPr lang="en-I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4B5C5B-8DA3-0B2C-D40F-3328413670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02A106-F657-87D9-C488-8529B4965C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17C82-8F7B-4DA2-9C2B-DDD40395D6D5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0520733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DBADB4F-42BD-526B-3E09-FB2037BA631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6012744-BEE4-4583-451F-A80F0BB8008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6B9A2E-2260-4E8A-E600-DFA4D05314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9C048-5EBA-48FE-B275-9A3CD1A75B26}" type="datetimeFigureOut">
              <a:rPr lang="en-IE" smtClean="0"/>
              <a:t>17/01/2025</a:t>
            </a:fld>
            <a:endParaRPr lang="en-I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1C19D8-DCEA-AEA0-488F-3CDF77E625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F1250B-8559-A179-6B1F-1BE75BE041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17C82-8F7B-4DA2-9C2B-DDD40395D6D5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5003617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A6B760-0FE8-95D0-1D3D-6FFB640C92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881D3FB-2AD6-E37D-58F4-7FD0A794B14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7B7C8E-94A4-01E1-FEAF-34D9E7B7D9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9C048-5EBA-48FE-B275-9A3CD1A75B26}" type="datetimeFigureOut">
              <a:rPr lang="en-IE" smtClean="0"/>
              <a:t>17/01/2025</a:t>
            </a:fld>
            <a:endParaRPr lang="en-I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935D0E-3953-959D-D3DB-647D367702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8ACD7D2-FA75-2BB0-EAB4-6C896D1142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17C82-8F7B-4DA2-9C2B-DDD40395D6D5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6658511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AB0B74-981B-A961-A8FC-689F030D66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B6A11CC-4F09-7E5E-BBE4-3424F81850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710F3B-A547-9CBC-CF6B-3A1C7E268A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9C048-5EBA-48FE-B275-9A3CD1A75B26}" type="datetimeFigureOut">
              <a:rPr lang="en-IE" smtClean="0"/>
              <a:t>17/01/2025</a:t>
            </a:fld>
            <a:endParaRPr lang="en-I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FB7F44-E4BF-EA76-1DA7-5193BB6A92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2A1EB91-8845-0507-5CFD-D11BACB981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17C82-8F7B-4DA2-9C2B-DDD40395D6D5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7326280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AD3882-D532-6DF7-EFFF-92BBE35B0E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436197-ABD8-4B7B-859F-F164F174890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C534AAD-BDE6-645F-A115-8354392E9B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0417D79-928D-1CDC-FE36-DCC56B34D7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9C048-5EBA-48FE-B275-9A3CD1A75B26}" type="datetimeFigureOut">
              <a:rPr lang="en-IE" smtClean="0"/>
              <a:t>17/01/2025</a:t>
            </a:fld>
            <a:endParaRPr lang="en-I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68744AD-36D1-DFDC-645E-9CD868C30B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7F9DDD8-F3D8-C4A5-596C-390EB4F038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17C82-8F7B-4DA2-9C2B-DDD40395D6D5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5619626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1FEC9E-B07E-66C7-51B1-0127DEC4B3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E5E6CE6-3A99-2F7F-9929-0FC5C24B5C7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0D0E307-13AD-BB7D-3044-8B2AFA14C3C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27280AB-3AFD-F522-39BF-1761FB90EB4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73E142D-E06F-A7D2-3867-6176B15AD3E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11BE35F-3E2D-E068-1668-D9CC3AF894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9C048-5EBA-48FE-B275-9A3CD1A75B26}" type="datetimeFigureOut">
              <a:rPr lang="en-IE" smtClean="0"/>
              <a:t>17/01/2025</a:t>
            </a:fld>
            <a:endParaRPr lang="en-I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2F06CE0-BD25-30F1-1D86-D8E45E2718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0FAF75B-D2D7-DC6E-452C-2FF311EB5C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17C82-8F7B-4DA2-9C2B-DDD40395D6D5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1772026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07F90C-9E5D-BDD9-EEA2-CB0FBE85CE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F7A66CD-0367-C165-7EF0-C31EE99025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9C048-5EBA-48FE-B275-9A3CD1A75B26}" type="datetimeFigureOut">
              <a:rPr lang="en-IE" smtClean="0"/>
              <a:t>17/01/2025</a:t>
            </a:fld>
            <a:endParaRPr lang="en-I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F1B033E-BAF3-C558-FC6C-FC8621C8F1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B15C884-4567-0CF6-ECE5-0136BAA1D2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17C82-8F7B-4DA2-9C2B-DDD40395D6D5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7231715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D3E0E23-68BE-70B6-1F42-90853D30D9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9C048-5EBA-48FE-B275-9A3CD1A75B26}" type="datetimeFigureOut">
              <a:rPr lang="en-IE" smtClean="0"/>
              <a:t>17/01/2025</a:t>
            </a:fld>
            <a:endParaRPr lang="en-I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171E3A0-318F-EB95-74DF-D56218183D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D8A7BBC-C587-4045-F3DB-5277CD8FD5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17C82-8F7B-4DA2-9C2B-DDD40395D6D5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5886179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539D90-73F0-A3C9-DF4A-BA061A8A9B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13F5D47-D0B5-FA5E-0594-205F04D57C9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D12D350-2366-53F1-8614-9A7E468590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4827F11-FE36-CB4F-0E71-5F666691A7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9C048-5EBA-48FE-B275-9A3CD1A75B26}" type="datetimeFigureOut">
              <a:rPr lang="en-IE" smtClean="0"/>
              <a:t>17/01/2025</a:t>
            </a:fld>
            <a:endParaRPr lang="en-I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E10CAFD-1288-E336-2E99-8E69D4E86F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ADEFF2C-4158-21BA-8A9A-180631EF89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17C82-8F7B-4DA2-9C2B-DDD40395D6D5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943230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104100-5747-6670-CE4D-44EDD470C4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B71DD67-FE24-61FD-90C8-2BF8C0255F8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DE79D47-86DE-DDE4-A6F2-E06B0733F64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E10B107-340E-D3E4-C559-3190715AF4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9C048-5EBA-48FE-B275-9A3CD1A75B26}" type="datetimeFigureOut">
              <a:rPr lang="en-IE" smtClean="0"/>
              <a:t>17/01/2025</a:t>
            </a:fld>
            <a:endParaRPr lang="en-I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E0C81DA-1998-0CF2-1636-CB04BD8A0E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4799F19-243D-CD16-D107-4DAE1934A1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17C82-8F7B-4DA2-9C2B-DDD40395D6D5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3787199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49A4384-9833-1309-55BA-85E2AC3479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FA10C32-E1FF-1058-C383-9180914CDB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66133C-8A35-D38A-F969-B17281D3ECF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89C048-5EBA-48FE-B275-9A3CD1A75B26}" type="datetimeFigureOut">
              <a:rPr lang="en-IE" smtClean="0"/>
              <a:t>17/01/2025</a:t>
            </a:fld>
            <a:endParaRPr lang="en-I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CDE8E0-18C7-34FC-7ECA-3ED6139D2B5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5E1A42-CB5F-649D-B077-E7886D27674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917C82-8F7B-4DA2-9C2B-DDD40395D6D5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5207293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s://github.com/rrwick/Porechop" TargetMode="External"/><Relationship Id="rId2" Type="http://schemas.openxmlformats.org/officeDocument/2006/relationships/hyperlink" Target="https://community.nanoporetech.com/protocols/Guppy-protocol/v/gpb_2003_v1_revl_14dec2018/linux-guppy" TargetMode="External"/><Relationship Id="rId1" Type="http://schemas.openxmlformats.org/officeDocument/2006/relationships/slideLayout" Target="../slideLayouts/slideLayout2.xml"/><Relationship Id="rId5" Type="http://schemas.openxmlformats.org/officeDocument/2006/relationships/hyperlink" Target="http://pcingola.github.io/SnpEff/" TargetMode="External"/><Relationship Id="rId4" Type="http://schemas.openxmlformats.org/officeDocument/2006/relationships/hyperlink" Target="https://github.com/lh3/seqtk" TargetMode="Externa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FAB13E27-E988-F080-D3F9-51424C70D07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62330780"/>
              </p:ext>
            </p:extLst>
          </p:nvPr>
        </p:nvGraphicFramePr>
        <p:xfrm>
          <a:off x="316071" y="218114"/>
          <a:ext cx="11680186" cy="5584496"/>
        </p:xfrm>
        <a:graphic>
          <a:graphicData uri="http://schemas.openxmlformats.org/drawingml/2006/table">
            <a:tbl>
              <a:tblPr firstRow="1" firstCol="1" bandRow="1"/>
              <a:tblGrid>
                <a:gridCol w="3158122">
                  <a:extLst>
                    <a:ext uri="{9D8B030D-6E8A-4147-A177-3AD203B41FA5}">
                      <a16:colId xmlns:a16="http://schemas.microsoft.com/office/drawing/2014/main" val="2012922582"/>
                    </a:ext>
                  </a:extLst>
                </a:gridCol>
                <a:gridCol w="2623655">
                  <a:extLst>
                    <a:ext uri="{9D8B030D-6E8A-4147-A177-3AD203B41FA5}">
                      <a16:colId xmlns:a16="http://schemas.microsoft.com/office/drawing/2014/main" val="543909624"/>
                    </a:ext>
                  </a:extLst>
                </a:gridCol>
                <a:gridCol w="5898409">
                  <a:extLst>
                    <a:ext uri="{9D8B030D-6E8A-4147-A177-3AD203B41FA5}">
                      <a16:colId xmlns:a16="http://schemas.microsoft.com/office/drawing/2014/main" val="2458129235"/>
                    </a:ext>
                  </a:extLst>
                </a:gridCol>
              </a:tblGrid>
              <a:tr h="11283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u="sng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oftware</a:t>
                      </a:r>
                      <a:endParaRPr lang="en-IE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Reference </a:t>
                      </a:r>
                      <a:endParaRPr lang="en-IE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ource </a:t>
                      </a:r>
                      <a:endParaRPr lang="en-IE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22045047"/>
                  </a:ext>
                </a:extLst>
              </a:tr>
              <a:tr h="19729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trimgalore</a:t>
                      </a:r>
                      <a:r>
                        <a:rPr lang="en-IE" sz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(Version 0.6.1)</a:t>
                      </a:r>
                      <a:endParaRPr lang="en-IE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Babraham Bioinformatics</a:t>
                      </a:r>
                      <a:endParaRPr lang="en-IE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u="sng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ttps://github.com/FelixKrueger/TrimGalore</a:t>
                      </a:r>
                      <a:endParaRPr lang="en-IE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79973165"/>
                  </a:ext>
                </a:extLst>
              </a:tr>
              <a:tr h="19729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BWA (Version 0.7.17). </a:t>
                      </a:r>
                      <a:endParaRPr lang="en-IE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Li and Durbin 2009 (1)</a:t>
                      </a:r>
                      <a:endParaRPr lang="en-IE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u="sng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ttp://bio-bwa.sourceforge.net/</a:t>
                      </a:r>
                      <a:endParaRPr lang="en-IE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3052266"/>
                  </a:ext>
                </a:extLst>
              </a:tr>
              <a:tr h="19729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amTools</a:t>
                      </a:r>
                      <a:endParaRPr lang="en-IE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Daneck</a:t>
                      </a:r>
                      <a:r>
                        <a:rPr lang="en-IE" sz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en-IE" sz="1200" i="1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et al., </a:t>
                      </a:r>
                      <a:r>
                        <a:rPr lang="en-IE" sz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021 (2)</a:t>
                      </a:r>
                      <a:endParaRPr lang="en-IE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u="sng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ttps://github.com/samtools/samtools</a:t>
                      </a:r>
                      <a:endParaRPr lang="en-IE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92320363"/>
                  </a:ext>
                </a:extLst>
              </a:tr>
              <a:tr h="19729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Ragtag (version 1.0.2)</a:t>
                      </a:r>
                      <a:endParaRPr lang="en-IE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longe</a:t>
                      </a:r>
                      <a:r>
                        <a:rPr lang="en-IE" sz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et al., 2019 (3)</a:t>
                      </a:r>
                      <a:endParaRPr lang="en-IE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u="sng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ttps://github.com/malonge/RagTag</a:t>
                      </a:r>
                      <a:endParaRPr lang="en-IE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4177481"/>
                  </a:ext>
                </a:extLst>
              </a:tr>
              <a:tr h="130545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icard (Version 2.18.23). </a:t>
                      </a:r>
                      <a:endParaRPr lang="en-IE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Broad Institute</a:t>
                      </a:r>
                      <a:endParaRPr lang="en-IE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u="sng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ttps://github.com/broadinstitute/picard</a:t>
                      </a:r>
                      <a:endParaRPr lang="en-IE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03392173"/>
                  </a:ext>
                </a:extLst>
              </a:tr>
              <a:tr h="19729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qualimap (Version 2.2.1</a:t>
                      </a:r>
                      <a:endParaRPr lang="en-IE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Okonechnikov</a:t>
                      </a:r>
                      <a:r>
                        <a:rPr lang="en-IE" sz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et al 2016 (4)</a:t>
                      </a:r>
                      <a:endParaRPr lang="en-IE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u="sng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ttp://qualimap.conesalab.org/doc_html/intro.html</a:t>
                      </a:r>
                      <a:endParaRPr lang="en-IE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53039752"/>
                  </a:ext>
                </a:extLst>
              </a:tr>
              <a:tr h="19729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PAdes (Version 3.14</a:t>
                      </a:r>
                      <a:endParaRPr lang="en-IE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Bankevich</a:t>
                      </a:r>
                      <a:r>
                        <a:rPr lang="en-IE" sz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et al., 2012 (5)</a:t>
                      </a:r>
                      <a:endParaRPr lang="en-IE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u="sng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ttps://cab.spbu.ru/software/spades/</a:t>
                      </a:r>
                      <a:endParaRPr lang="en-IE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6451686"/>
                  </a:ext>
                </a:extLst>
              </a:tr>
              <a:tr h="264036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uppy (version 3.6)</a:t>
                      </a:r>
                      <a:endParaRPr lang="en-IE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Oxford Nanopore Technologies Ltd</a:t>
                      </a:r>
                      <a:endParaRPr lang="en-IE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u="sng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  <a:hlinkClick r:id="rId2">
                            <a:extLst>
                              <a:ext uri="{A12FA001-AC4F-418D-AE19-62706E023703}">
                                <ahyp:hlinkClr xmlns:ahyp="http://schemas.microsoft.com/office/drawing/2018/hyperlinkcolor" val="tx"/>
                              </a:ext>
                            </a:extLst>
                          </a:hlinkClick>
                        </a:rPr>
                        <a:t>https://community.nanoporetech.com/protocols/Guppy-protocol/v/gpb_2003_v1_revl_14dec2018/linux-guppy</a:t>
                      </a:r>
                      <a:endParaRPr lang="en-IE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6197660"/>
                  </a:ext>
                </a:extLst>
              </a:tr>
              <a:tr h="19729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anofilt</a:t>
                      </a:r>
                      <a:endParaRPr lang="en-IE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De </a:t>
                      </a:r>
                      <a:r>
                        <a:rPr lang="en-IE" sz="1200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oster</a:t>
                      </a:r>
                      <a:r>
                        <a:rPr lang="en-IE" sz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et al., 2018 (6)</a:t>
                      </a:r>
                      <a:endParaRPr lang="en-IE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u="sng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ttps://github.com/wdecoster/nanofilt</a:t>
                      </a:r>
                      <a:endParaRPr lang="en-IE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94179651"/>
                  </a:ext>
                </a:extLst>
              </a:tr>
              <a:tr h="19729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orechop (version 6)</a:t>
                      </a:r>
                      <a:endParaRPr lang="en-IE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Murigneux</a:t>
                      </a:r>
                      <a:r>
                        <a:rPr lang="en-IE" sz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et al., 2020 (7) </a:t>
                      </a:r>
                      <a:endParaRPr lang="en-IE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u="sng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  <a:hlinkClick r:id="rId3">
                            <a:extLst>
                              <a:ext uri="{A12FA001-AC4F-418D-AE19-62706E023703}">
                                <ahyp:hlinkClr xmlns:ahyp="http://schemas.microsoft.com/office/drawing/2018/hyperlinkcolor" val="tx"/>
                              </a:ext>
                            </a:extLst>
                          </a:hlinkClick>
                        </a:rPr>
                        <a:t>https://github.com/rrwick/Porechop</a:t>
                      </a:r>
                      <a:endParaRPr lang="en-IE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74844667"/>
                  </a:ext>
                </a:extLst>
              </a:tr>
              <a:tr h="130545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eqtk (version 1.3)</a:t>
                      </a:r>
                      <a:endParaRPr lang="en-IE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MIT Licence</a:t>
                      </a:r>
                      <a:endParaRPr lang="en-IE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u="sng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  <a:hlinkClick r:id="rId4">
                            <a:extLst>
                              <a:ext uri="{A12FA001-AC4F-418D-AE19-62706E023703}">
                                <ahyp:hlinkClr xmlns:ahyp="http://schemas.microsoft.com/office/drawing/2018/hyperlinkcolor" val="tx"/>
                              </a:ext>
                            </a:extLst>
                          </a:hlinkClick>
                        </a:rPr>
                        <a:t>https://github.com/lh3/seqtk</a:t>
                      </a:r>
                      <a:endParaRPr lang="en-IE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87938461"/>
                  </a:ext>
                </a:extLst>
              </a:tr>
              <a:tr h="19729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Flye (version 2.8)</a:t>
                      </a:r>
                      <a:endParaRPr lang="en-IE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Kolmogorov et al., 2020 (8)</a:t>
                      </a:r>
                      <a:endParaRPr lang="en-IE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u="sng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ttps://github.com/fenderglass/Flye</a:t>
                      </a:r>
                      <a:endParaRPr lang="en-IE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79159085"/>
                  </a:ext>
                </a:extLst>
              </a:tr>
              <a:tr h="264036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Medaka (version 1.0.3)</a:t>
                      </a:r>
                      <a:endParaRPr lang="en-IE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Oxford Nanopore Technologies Ltd</a:t>
                      </a:r>
                      <a:endParaRPr lang="en-IE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u="sng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ttps://github.com/nanoporetech/medaka</a:t>
                      </a:r>
                      <a:endParaRPr lang="en-IE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66516709"/>
                  </a:ext>
                </a:extLst>
              </a:tr>
              <a:tr h="19729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Quast 5.10.0 </a:t>
                      </a:r>
                      <a:endParaRPr lang="en-IE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Qusat</a:t>
                      </a: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 </a:t>
                      </a:r>
                      <a:endParaRPr lang="en-IE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https://github.com/ablab/quast</a:t>
                      </a: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98528906"/>
                  </a:ext>
                </a:extLst>
              </a:tr>
              <a:tr h="19729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Busco (version 3)</a:t>
                      </a:r>
                      <a:endParaRPr lang="en-IE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Waterhouse et al., 2018 (9)</a:t>
                      </a:r>
                      <a:endParaRPr lang="en-IE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u="sng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ttps://gitlab.com/ezlab/busco</a:t>
                      </a:r>
                      <a:endParaRPr lang="en-IE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2772271"/>
                  </a:ext>
                </a:extLst>
              </a:tr>
              <a:tr h="19729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Funannotate</a:t>
                      </a:r>
                      <a:r>
                        <a:rPr lang="en-IE" sz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(version 1.74)</a:t>
                      </a:r>
                      <a:endParaRPr lang="en-IE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almer and </a:t>
                      </a:r>
                      <a:r>
                        <a:rPr lang="en-IE" sz="1200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tajich</a:t>
                      </a:r>
                      <a:r>
                        <a:rPr lang="en-IE" sz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2019 (10)</a:t>
                      </a:r>
                      <a:endParaRPr lang="en-IE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u="sng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ttps://github.com/nextgenusfs/funannotate</a:t>
                      </a:r>
                      <a:endParaRPr lang="en-IE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92715371"/>
                  </a:ext>
                </a:extLst>
              </a:tr>
              <a:tr h="264036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ATK (version 4.1.4-1)</a:t>
                      </a:r>
                      <a:endParaRPr lang="en-IE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l-NL" sz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Van der Auwera and O'Connor 2020 (11)</a:t>
                      </a:r>
                      <a:endParaRPr lang="en-IE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l-NL" sz="1200" u="sng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ttps://github.com/broadinstitute/gatk/releases</a:t>
                      </a:r>
                      <a:endParaRPr lang="en-IE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29016846"/>
                  </a:ext>
                </a:extLst>
              </a:tr>
              <a:tr h="19729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npEff (version 4.3)</a:t>
                      </a:r>
                      <a:endParaRPr lang="en-IE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ingolani</a:t>
                      </a:r>
                      <a:r>
                        <a:rPr lang="en-IE" sz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et al., 2012 (12)</a:t>
                      </a:r>
                      <a:endParaRPr lang="en-IE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l-NL" sz="1200" u="sng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  <a:hlinkClick r:id="rId5">
                            <a:extLst>
                              <a:ext uri="{A12FA001-AC4F-418D-AE19-62706E023703}">
                                <ahyp:hlinkClr xmlns:ahyp="http://schemas.microsoft.com/office/drawing/2018/hyperlinkcolor" val="tx"/>
                              </a:ext>
                            </a:extLst>
                          </a:hlinkClick>
                        </a:rPr>
                        <a:t>http://pcingola.github.io/SnpEff/</a:t>
                      </a:r>
                      <a:endParaRPr lang="en-IE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22478952"/>
                  </a:ext>
                </a:extLst>
              </a:tr>
              <a:tr h="19729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Orthofinder (version 2.3.3)</a:t>
                      </a:r>
                      <a:endParaRPr lang="en-IE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Emms and Kelly 2019 (13)</a:t>
                      </a:r>
                      <a:endParaRPr lang="en-IE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ttps://github.com/davidemms/OrthoFinder</a:t>
                      </a:r>
                      <a:endParaRPr lang="en-IE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12038002"/>
                  </a:ext>
                </a:extLst>
              </a:tr>
              <a:tr h="19729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MUSCLE (version 3.8.31)</a:t>
                      </a:r>
                      <a:endParaRPr lang="en-IE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European Bioinformatics Institute</a:t>
                      </a:r>
                      <a:endParaRPr lang="en-IE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ttps://www.ebi.ac.uk/Tools/msa/muscle/</a:t>
                      </a:r>
                      <a:endParaRPr lang="en-IE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88283252"/>
                  </a:ext>
                </a:extLst>
              </a:tr>
              <a:tr h="130545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RAxML (version 8)</a:t>
                      </a:r>
                      <a:endParaRPr lang="en-IE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tamatakis 2014 (14)</a:t>
                      </a:r>
                      <a:endParaRPr lang="en-IE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ttps://github.com/stamatak/standard-RAxML</a:t>
                      </a:r>
                      <a:endParaRPr lang="en-IE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4268583"/>
                  </a:ext>
                </a:extLst>
              </a:tr>
              <a:tr h="130545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gtree</a:t>
                      </a:r>
                      <a:r>
                        <a:rPr lang="en-IE" sz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(version 3.6.2)</a:t>
                      </a:r>
                      <a:endParaRPr lang="en-IE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 Yu et al., 2017 (15)</a:t>
                      </a:r>
                      <a:endParaRPr lang="en-IE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ttps://yulab-smu.top/</a:t>
                      </a:r>
                      <a:endParaRPr lang="en-IE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8275619"/>
                  </a:ext>
                </a:extLst>
              </a:tr>
              <a:tr h="19729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link (version 1.09)</a:t>
                      </a:r>
                      <a:endParaRPr lang="en-IE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urcell et al., 2007 (16)</a:t>
                      </a:r>
                      <a:endParaRPr lang="en-IE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ttps://www.cog-genomics.org/plink/</a:t>
                      </a:r>
                      <a:endParaRPr lang="en-IE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43496474"/>
                  </a:ext>
                </a:extLst>
              </a:tr>
              <a:tr h="130545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fastSTRUCTURE (version 10)</a:t>
                      </a:r>
                      <a:endParaRPr lang="en-IE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Raj et al., 2014 (17)</a:t>
                      </a:r>
                      <a:endParaRPr lang="en-IE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ttps://rajanil.github.io/fastStructure/</a:t>
                      </a:r>
                      <a:endParaRPr lang="en-IE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23028971"/>
                  </a:ext>
                </a:extLst>
              </a:tr>
              <a:tr h="19729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ontrol -FREEC (version 5.7)</a:t>
                      </a:r>
                      <a:endParaRPr lang="en-IE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Boeva</a:t>
                      </a:r>
                      <a:r>
                        <a:rPr lang="en-IE" sz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en-IE" sz="1200" i="1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et al., </a:t>
                      </a:r>
                      <a:r>
                        <a:rPr lang="en-IE" sz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2012 (18)</a:t>
                      </a:r>
                      <a:endParaRPr lang="en-IE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ttps://github.com/BoevaLab/FREEC</a:t>
                      </a:r>
                      <a:endParaRPr lang="en-IE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17986153"/>
                  </a:ext>
                </a:extLst>
              </a:tr>
              <a:tr h="19729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Fijarczyk2020_JeanTalon </a:t>
                      </a:r>
                      <a:endParaRPr lang="en-IE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Fijarczyk</a:t>
                      </a:r>
                      <a:r>
                        <a:rPr lang="en-IE" sz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en-IE" sz="1200" i="1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et al., </a:t>
                      </a:r>
                      <a:r>
                        <a:rPr lang="en-IE" sz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020 (19)</a:t>
                      </a:r>
                      <a:endParaRPr lang="en-IE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E" sz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ttps://github.com/Landrylab/Fijarczyk2020_JeanTalon</a:t>
                      </a:r>
                      <a:endParaRPr lang="en-IE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35713" marR="3571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22848239"/>
                  </a:ext>
                </a:extLst>
              </a:tr>
            </a:tbl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9AFD5565-5308-5DA4-FF2F-FE15ADBF1D90}"/>
              </a:ext>
            </a:extLst>
          </p:cNvPr>
          <p:cNvSpPr txBox="1"/>
          <p:nvPr/>
        </p:nvSpPr>
        <p:spPr>
          <a:xfrm>
            <a:off x="241618" y="6121795"/>
            <a:ext cx="6381032" cy="103618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sz="1600" b="0" i="0" u="none" strike="noStrike" baseline="0" dirty="0">
                <a:latin typeface="CIDFont+F2"/>
              </a:rPr>
              <a:t>Supplementary Table 1:</a:t>
            </a:r>
            <a:r>
              <a:rPr lang="en-IE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Bioinformatic programmes used in this study</a:t>
            </a:r>
            <a:r>
              <a:rPr lang="en-IE" sz="16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. </a:t>
            </a:r>
          </a:p>
          <a:p>
            <a:pPr algn="just">
              <a:spcAft>
                <a:spcPts val="800"/>
              </a:spcAft>
            </a:pPr>
            <a:endParaRPr lang="en-IE" sz="1600" dirty="0">
              <a:latin typeface="Calibri" panose="020F0502020204030204" pitchFamily="34" charset="0"/>
              <a:ea typeface="Yu Mincho" panose="02020400000000000000" pitchFamily="18" charset="-128"/>
              <a:cs typeface="Calibri" panose="020F0502020204030204" pitchFamily="34" charset="0"/>
            </a:endParaRPr>
          </a:p>
          <a:p>
            <a:pPr algn="just">
              <a:spcAft>
                <a:spcPts val="800"/>
              </a:spcAft>
            </a:pPr>
            <a:endParaRPr lang="en-IE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</p:txBody>
      </p:sp>
    </p:spTree>
    <p:extLst>
      <p:ext uri="{BB962C8B-B14F-4D97-AF65-F5344CB8AC3E}">
        <p14:creationId xmlns:p14="http://schemas.microsoft.com/office/powerpoint/2010/main" val="39448101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EE03A2D-DA04-723A-0852-1E2BF2A1A587}"/>
              </a:ext>
            </a:extLst>
          </p:cNvPr>
          <p:cNvSpPr txBox="1">
            <a:spLocks noGrp="1"/>
          </p:cNvSpPr>
          <p:nvPr>
            <p:ph idx="1"/>
          </p:nvPr>
        </p:nvSpPr>
        <p:spPr>
          <a:xfrm>
            <a:off x="391391" y="0"/>
            <a:ext cx="11464636" cy="749910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just">
              <a:lnSpc>
                <a:spcPct val="200000"/>
              </a:lnSpc>
              <a:buClr>
                <a:srgbClr val="222222"/>
              </a:buClr>
              <a:buSzPts val="1000"/>
              <a:buNone/>
            </a:pP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eferences:</a:t>
            </a:r>
          </a:p>
          <a:p>
            <a:pPr marL="342900" lvl="0" indent="-342900" algn="just">
              <a:lnSpc>
                <a:spcPct val="200000"/>
              </a:lnSpc>
              <a:spcBef>
                <a:spcPts val="1200"/>
              </a:spcBef>
              <a:spcAft>
                <a:spcPts val="0"/>
              </a:spcAft>
              <a:buClr>
                <a:srgbClr val="222222"/>
              </a:buClr>
              <a:buSzPts val="1000"/>
              <a:buFont typeface="Arial" panose="020B0604020202020204" pitchFamily="34" charset="0"/>
              <a:buAutoNum type="arabicPeriod"/>
            </a:pP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i, H. and Durbin, R. Fast and accurate short read alignment with Burrows–Wheeler transform. </a:t>
            </a:r>
            <a:r>
              <a:rPr lang="en-IE" sz="12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ioinformatics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 </a:t>
            </a:r>
            <a:r>
              <a:rPr lang="en-IE" sz="12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5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14), pp.1754-1760 (2009).</a:t>
            </a:r>
            <a:endParaRPr lang="en-IE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  <a:p>
            <a:pPr marL="342900" lvl="0" indent="-342900" algn="just">
              <a:lnSpc>
                <a:spcPct val="200000"/>
              </a:lnSpc>
              <a:buClr>
                <a:srgbClr val="222222"/>
              </a:buClr>
              <a:buSzPts val="1000"/>
              <a:buFont typeface="Arial" panose="020B0604020202020204" pitchFamily="34" charset="0"/>
              <a:buAutoNum type="arabicPeriod"/>
            </a:pP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anecek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P.,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onfield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J.K., Liddle, J., Marshall, J., Ohan, V., Pollard, M.O.,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Whitwham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A., Keane, T., McCarthy, S.A., Davies, R.M. and Li, H., 2021. Twelve years of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AMtools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and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CFtools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 </a:t>
            </a:r>
            <a:r>
              <a:rPr lang="en-IE" sz="1200" i="1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igascience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 </a:t>
            </a:r>
            <a:r>
              <a:rPr lang="en-IE" sz="12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0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2), p.giab008.</a:t>
            </a:r>
          </a:p>
          <a:p>
            <a:pPr marL="342900" indent="-342900" algn="just">
              <a:lnSpc>
                <a:spcPct val="200000"/>
              </a:lnSpc>
              <a:buClr>
                <a:srgbClr val="222222"/>
              </a:buClr>
              <a:buSzPts val="1000"/>
              <a:buFont typeface="Arial" panose="020B0604020202020204" pitchFamily="34" charset="0"/>
              <a:buAutoNum type="arabicPeriod"/>
            </a:pP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longe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M.,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oyk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S., Ramakrishnan, S., Wang, X., Goodwin, S.,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edlazeck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F.J., Lippman, Z.B. and Schatz, M.C.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aGOO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: fast and accurate reference-guided scaffolding of draft genomes. </a:t>
            </a:r>
            <a:r>
              <a:rPr lang="en-IE" sz="12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enome biology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 </a:t>
            </a:r>
            <a:r>
              <a:rPr lang="en-IE" sz="12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0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1), pp.1-17 (2019).</a:t>
            </a:r>
            <a:endParaRPr lang="en-IE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  <a:p>
            <a:pPr marL="342900" lvl="0" indent="-342900" algn="just">
              <a:lnSpc>
                <a:spcPct val="200000"/>
              </a:lnSpc>
              <a:buClr>
                <a:srgbClr val="222222"/>
              </a:buClr>
              <a:buSzPts val="1000"/>
              <a:buFont typeface="Arial" panose="020B0604020202020204" pitchFamily="34" charset="0"/>
              <a:buAutoNum type="arabicPeriod"/>
            </a:pP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Okonechnikov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K., Conesa, A. and García-Alcalde, F.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Qualimap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2: advanced multi-sample quality control for high-throughput sequencing data. </a:t>
            </a:r>
            <a:r>
              <a:rPr lang="en-IE" sz="12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ioinformatics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 </a:t>
            </a:r>
            <a:r>
              <a:rPr lang="en-IE" sz="12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32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2), pp.292-294 (2016).</a:t>
            </a:r>
            <a:endParaRPr lang="en-IE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  <a:p>
            <a:pPr marL="342900" lvl="0" indent="-342900" algn="just">
              <a:lnSpc>
                <a:spcPct val="200000"/>
              </a:lnSpc>
              <a:buClr>
                <a:srgbClr val="222222"/>
              </a:buClr>
              <a:buSzPts val="1000"/>
              <a:buFont typeface="Arial" panose="020B0604020202020204" pitchFamily="34" charset="0"/>
              <a:buAutoNum type="arabicPeriod"/>
            </a:pP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ankevich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A.,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urk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S.,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ntipov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D., Gurevich, A.A.,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vorkin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M., Kulikov, A.S.,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esin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V.M.,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ikolenko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S.I., Pham, S.,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rjibelski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A.D. and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yshkin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A.V.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PAdes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: a new genome assembly algorithm and its applications to single-cell sequencing. </a:t>
            </a:r>
            <a:r>
              <a:rPr lang="en-IE" sz="12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Journal of computational biology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 </a:t>
            </a:r>
            <a:r>
              <a:rPr lang="en-IE" sz="12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9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5), pp.455-477 (2012).</a:t>
            </a:r>
          </a:p>
          <a:p>
            <a:pPr marL="342900" indent="-342900" algn="just">
              <a:lnSpc>
                <a:spcPct val="200000"/>
              </a:lnSpc>
              <a:buClr>
                <a:srgbClr val="222222"/>
              </a:buClr>
              <a:buSzPts val="1000"/>
              <a:buFont typeface="+mj-lt"/>
              <a:buAutoNum type="arabicPeriod" startAt="6"/>
            </a:pP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e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oster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W.,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’Hert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S., Schultz, D.T.,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ruts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M. and Van Broeckhoven, C.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anoPack:visualizing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and processing long-read sequencing data. </a:t>
            </a:r>
            <a:r>
              <a:rPr lang="en-IE" sz="12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ioinformatics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 </a:t>
            </a:r>
            <a:r>
              <a:rPr lang="en-IE" sz="12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34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15), pp.2666-2669 (2018).</a:t>
            </a:r>
            <a:endParaRPr lang="en-IE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  <a:p>
            <a:pPr marL="342900" lvl="0" indent="-342900" algn="just">
              <a:lnSpc>
                <a:spcPct val="200000"/>
              </a:lnSpc>
              <a:buClr>
                <a:srgbClr val="222222"/>
              </a:buClr>
              <a:buSzPts val="1000"/>
              <a:buFont typeface="+mj-lt"/>
              <a:buAutoNum type="arabicPeriod" startAt="6"/>
            </a:pP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urigneux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V., Rai, S.K., Furtado, A.,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ruxner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T.J., Tian, W.,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arliwong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I., Wei, H., Yang, B., Ye, Q., Anderson, E. and Mao, Q. Comparison of long-read methods for sequencing and assembly of a plant genome. </a:t>
            </a:r>
            <a:r>
              <a:rPr lang="en-IE" sz="1200" i="1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igaScience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 </a:t>
            </a:r>
            <a:r>
              <a:rPr lang="en-IE" sz="12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9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12), p.giaa146 (2020).</a:t>
            </a:r>
            <a:endParaRPr lang="en-IE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  <a:p>
            <a:pPr marL="342900" lvl="0" indent="-342900" algn="just">
              <a:lnSpc>
                <a:spcPct val="200000"/>
              </a:lnSpc>
              <a:buClr>
                <a:srgbClr val="222222"/>
              </a:buClr>
              <a:buSzPts val="1000"/>
              <a:buFont typeface="+mj-lt"/>
              <a:buAutoNum type="arabicPeriod" startAt="6"/>
            </a:pP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olmogorov, M.,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ickhart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D.M.,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ehsaz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B., Gurevich, A.,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ayko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M., Shin, S.B., Kuhn, K., Yuan, J.,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olevikov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E., Smith, T.P. and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evzner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P.A.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etaFlye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: scalable long-read metagenome assembly using repeat graphs. </a:t>
            </a:r>
            <a:r>
              <a:rPr lang="en-IE" sz="12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ature Methods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 </a:t>
            </a:r>
            <a:r>
              <a:rPr lang="en-IE" sz="12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7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11), pp.1103-1110 (2020).</a:t>
            </a:r>
            <a:endParaRPr lang="en-IE" sz="1200" dirty="0"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  <a:p>
            <a:pPr marL="342900" lvl="0" indent="-342900" algn="just">
              <a:lnSpc>
                <a:spcPct val="200000"/>
              </a:lnSpc>
              <a:buClr>
                <a:srgbClr val="222222"/>
              </a:buClr>
              <a:buSzPts val="1000"/>
              <a:buFont typeface="Arial" panose="020B0604020202020204" pitchFamily="34" charset="0"/>
              <a:buAutoNum type="arabicPeriod"/>
            </a:pPr>
            <a:endParaRPr lang="en-IE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</p:txBody>
      </p:sp>
    </p:spTree>
    <p:extLst>
      <p:ext uri="{BB962C8B-B14F-4D97-AF65-F5344CB8AC3E}">
        <p14:creationId xmlns:p14="http://schemas.microsoft.com/office/powerpoint/2010/main" val="979628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1740749-5AE4-65C3-2055-3502A14E88C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755073" y="339725"/>
            <a:ext cx="10515600" cy="4351338"/>
          </a:xfrm>
        </p:spPr>
        <p:txBody>
          <a:bodyPr>
            <a:noAutofit/>
          </a:bodyPr>
          <a:lstStyle/>
          <a:p>
            <a:pPr marL="342900" lvl="0" indent="-342900" algn="just">
              <a:lnSpc>
                <a:spcPct val="200000"/>
              </a:lnSpc>
              <a:buClr>
                <a:srgbClr val="222222"/>
              </a:buClr>
              <a:buSzPts val="1000"/>
              <a:buFont typeface="+mj-lt"/>
              <a:buAutoNum type="arabicPeriod" startAt="9"/>
            </a:pP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Waterhouse, R.M.,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eppey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M.,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imão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F.A., Manni, M., Ioannidis, P.,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lioutchnikov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G.,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riventseva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E.V. and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Zdobnov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E.M. BUSCO applications from quality assessments to gene prediction and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hylogenomics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 </a:t>
            </a:r>
            <a:r>
              <a:rPr lang="en-IE" sz="12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olecular biology and evolution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 </a:t>
            </a:r>
            <a:r>
              <a:rPr lang="en-IE" sz="12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35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3), pp.543-548 (2018).</a:t>
            </a:r>
            <a:endParaRPr lang="en-IE" sz="120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  <a:p>
            <a:pPr marL="342900" lvl="0" indent="-342900" algn="just">
              <a:lnSpc>
                <a:spcPct val="200000"/>
              </a:lnSpc>
              <a:buClr>
                <a:srgbClr val="222222"/>
              </a:buClr>
              <a:buSzPts val="1000"/>
              <a:buFont typeface="+mj-lt"/>
              <a:buAutoNum type="arabicPeriod" startAt="9"/>
            </a:pPr>
            <a:r>
              <a:rPr lang="en-IE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almer, J. &amp; </a:t>
            </a:r>
            <a:r>
              <a:rPr lang="en-IE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tajich</a:t>
            </a:r>
            <a:r>
              <a:rPr lang="en-IE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J. </a:t>
            </a:r>
            <a:r>
              <a:rPr lang="en-IE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extgenusfs</a:t>
            </a:r>
            <a:r>
              <a:rPr lang="en-IE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/</a:t>
            </a:r>
            <a:r>
              <a:rPr lang="en-IE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unannotate</a:t>
            </a:r>
            <a:r>
              <a:rPr lang="en-IE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: </a:t>
            </a:r>
            <a:r>
              <a:rPr lang="en-IE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unannotate</a:t>
            </a:r>
            <a:r>
              <a:rPr lang="en-IE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v1.5.3 (Version 1.5.3). </a:t>
            </a:r>
            <a:r>
              <a:rPr lang="en-IE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Zenodo</a:t>
            </a:r>
            <a:r>
              <a:rPr lang="en-IE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https://doi.org/10.5281/zenodo.2604804 (2019)</a:t>
            </a:r>
            <a:endParaRPr lang="en-IE" sz="1200" dirty="0"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  <a:p>
            <a:pPr marL="342900" lvl="0" indent="-342900" algn="just">
              <a:lnSpc>
                <a:spcPct val="200000"/>
              </a:lnSpc>
              <a:buClr>
                <a:srgbClr val="222222"/>
              </a:buClr>
              <a:buSzPts val="1000"/>
              <a:buFont typeface="+mj-lt"/>
              <a:buAutoNum type="arabicPeriod" startAt="9"/>
            </a:pP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Van der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uwera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G.A. and O'Connor, B.D. </a:t>
            </a:r>
            <a:r>
              <a:rPr lang="en-IE" sz="12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enomics in the cloud: using Docker, GATK, and WDL in Terra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O'Reilly Media (2020).</a:t>
            </a:r>
            <a:endParaRPr lang="en-IE" sz="1200" dirty="0"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  <a:p>
            <a:pPr marL="342900" lvl="0" indent="-342900" algn="just">
              <a:lnSpc>
                <a:spcPct val="200000"/>
              </a:lnSpc>
              <a:buClr>
                <a:srgbClr val="222222"/>
              </a:buClr>
              <a:buSzPts val="1000"/>
              <a:buFont typeface="+mj-lt"/>
              <a:buAutoNum type="arabicPeriod" startAt="9"/>
            </a:pP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ingolani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P., Platts, A., Wang, L.L., Coon, M., Nguyen, T., Wang, L., Land, S.J., Lu, X. and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uden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D.M. A program for annotating and predicting the effects of single nucleotide polymorphisms,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npEff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: SNPs in the genome of Drosophila melanogaster strain w1118; iso-2; iso-3. </a:t>
            </a:r>
            <a:r>
              <a:rPr lang="en-IE" sz="12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ly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 </a:t>
            </a:r>
            <a:r>
              <a:rPr lang="en-IE" sz="12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6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2), pp.80-92 (2012).</a:t>
            </a:r>
            <a:endParaRPr lang="en-IE" sz="1200" dirty="0"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  <a:p>
            <a:pPr marL="342900" lvl="0" indent="-342900" algn="just">
              <a:lnSpc>
                <a:spcPct val="200000"/>
              </a:lnSpc>
              <a:buClr>
                <a:srgbClr val="222222"/>
              </a:buClr>
              <a:buSzPts val="1000"/>
              <a:buFont typeface="+mj-lt"/>
              <a:buAutoNum type="arabicPeriod" startAt="9"/>
            </a:pP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mms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D.M. and Kelly, S., 2019.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OrthoFinder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: phylogenetic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orthology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inference for comparative genomics. </a:t>
            </a:r>
            <a:r>
              <a:rPr lang="en-IE" sz="12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enome biology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 </a:t>
            </a:r>
            <a:r>
              <a:rPr lang="en-IE" sz="12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0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pp.1-14.</a:t>
            </a:r>
            <a:endParaRPr lang="en-IE" sz="1200" dirty="0"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  <a:p>
            <a:pPr marL="342900" lvl="0" indent="-342900" algn="just">
              <a:lnSpc>
                <a:spcPct val="200000"/>
              </a:lnSpc>
              <a:buClr>
                <a:srgbClr val="222222"/>
              </a:buClr>
              <a:buSzPts val="1000"/>
              <a:buFont typeface="+mj-lt"/>
              <a:buAutoNum type="arabicPeriod" startAt="9"/>
            </a:pP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tamatakis, A., 2014.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AxML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version 8: a tool for phylogenetic analysis and post-analysis of large phylogenies. </a:t>
            </a:r>
            <a:r>
              <a:rPr lang="en-IE" sz="12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ioinformatics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 </a:t>
            </a:r>
            <a:r>
              <a:rPr lang="en-IE" sz="12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30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9), pp.1312-1313.</a:t>
            </a:r>
          </a:p>
          <a:p>
            <a:pPr marL="514350" lvl="0" indent="-514350" algn="just">
              <a:lnSpc>
                <a:spcPct val="200000"/>
              </a:lnSpc>
              <a:buClr>
                <a:srgbClr val="222222"/>
              </a:buClr>
              <a:buSzPts val="1000"/>
              <a:buFont typeface="+mj-lt"/>
              <a:buAutoNum type="arabicPeriod" startAt="15"/>
            </a:pP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Yu, G., Lam, T.T.Y., Zhu, H. and Guan, Y., 2018. Two methods for mapping and visualizing associated data on phylogeny using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gtree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 </a:t>
            </a:r>
            <a:r>
              <a:rPr lang="en-IE" sz="12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olecular biology and evolution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 </a:t>
            </a:r>
            <a:r>
              <a:rPr lang="en-IE" sz="12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35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12), pp.3041-3043.</a:t>
            </a:r>
            <a:endParaRPr lang="en-IE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  <a:p>
            <a:pPr marL="514350" lvl="0" indent="-514350" algn="just">
              <a:lnSpc>
                <a:spcPct val="200000"/>
              </a:lnSpc>
              <a:buClr>
                <a:srgbClr val="222222"/>
              </a:buClr>
              <a:buSzPts val="1000"/>
              <a:buFont typeface="+mj-lt"/>
              <a:buAutoNum type="arabicPeriod" startAt="15"/>
            </a:pP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urcell, S., Neale, B., Todd-Brown, K., Thomas, L., Ferreira, M.A., Bender, D.,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aller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J.,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klar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P., De Bakker, P.I., Daly, M.J. and Sham, P.C., 2007. PLINK: a tool set for whole-genome association and population-based linkage analyses. </a:t>
            </a:r>
            <a:r>
              <a:rPr lang="en-IE" sz="12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he American journal of human genetics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 </a:t>
            </a:r>
            <a:r>
              <a:rPr lang="en-IE" sz="12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81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3), pp.559-575.</a:t>
            </a:r>
            <a:endParaRPr lang="en-IE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  <a:p>
            <a:pPr marL="342900" lvl="0" indent="-342900" algn="just">
              <a:lnSpc>
                <a:spcPct val="200000"/>
              </a:lnSpc>
              <a:buClr>
                <a:srgbClr val="222222"/>
              </a:buClr>
              <a:buSzPts val="1000"/>
              <a:buFont typeface="+mj-lt"/>
              <a:buAutoNum type="arabicPeriod" startAt="15"/>
            </a:pPr>
            <a:endParaRPr lang="en-IE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  <a:p>
            <a:pPr marL="0" indent="0">
              <a:lnSpc>
                <a:spcPct val="107000"/>
              </a:lnSpc>
              <a:spcAft>
                <a:spcPts val="800"/>
              </a:spcAft>
              <a:buNone/>
            </a:pPr>
            <a:r>
              <a:rPr lang="en-IE" sz="12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Cordia New" panose="020B0304020202020204" pitchFamily="34" charset="-34"/>
              </a:rPr>
              <a:t> </a:t>
            </a:r>
          </a:p>
          <a:p>
            <a:endParaRPr lang="en-IE" sz="1200" dirty="0"/>
          </a:p>
        </p:txBody>
      </p:sp>
    </p:spTree>
    <p:extLst>
      <p:ext uri="{BB962C8B-B14F-4D97-AF65-F5344CB8AC3E}">
        <p14:creationId xmlns:p14="http://schemas.microsoft.com/office/powerpoint/2010/main" val="27050272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9E1AD29-C171-2E71-D8DA-B9071BB0608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734291" y="765752"/>
            <a:ext cx="10515600" cy="3825566"/>
          </a:xfrm>
        </p:spPr>
        <p:txBody>
          <a:bodyPr>
            <a:normAutofit/>
          </a:bodyPr>
          <a:lstStyle/>
          <a:p>
            <a:pPr marL="514350" lvl="0" indent="-514350" algn="just">
              <a:lnSpc>
                <a:spcPct val="200000"/>
              </a:lnSpc>
              <a:buClr>
                <a:srgbClr val="222222"/>
              </a:buClr>
              <a:buSzPts val="1000"/>
              <a:buFont typeface="+mj-lt"/>
              <a:buAutoNum type="arabicPeriod" startAt="17"/>
            </a:pP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aj, A., Stephens, M. and Pritchard, J.K., 2014.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astSTRUCTURE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: variational inference of population structure in large SNP data sets. </a:t>
            </a:r>
            <a:r>
              <a:rPr lang="en-IE" sz="12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enetics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 </a:t>
            </a:r>
            <a:r>
              <a:rPr lang="en-IE" sz="12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97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2), pp.573-589.Salazar, A.N. and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beel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T., 2019. Alpaca: a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mer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based approach for investigating mosaic structures in microbial genomes. </a:t>
            </a:r>
            <a:r>
              <a:rPr lang="en-IE" sz="1200" i="1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ioRxiv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p.551234.</a:t>
            </a:r>
            <a:endParaRPr lang="en-IE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  <a:p>
            <a:pPr marL="514350" lvl="0" indent="-514350" algn="just">
              <a:lnSpc>
                <a:spcPct val="200000"/>
              </a:lnSpc>
              <a:buClr>
                <a:srgbClr val="222222"/>
              </a:buClr>
              <a:buSzPts val="1000"/>
              <a:buFont typeface="+mj-lt"/>
              <a:buAutoNum type="arabicPeriod" startAt="17"/>
            </a:pP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oeva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V., Popova, T.,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leakley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K.,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hiche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P.,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appo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J., Schleiermacher, G.,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Janoueix-Lerosey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I., Delattre, O. and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arillot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E., 2012. Control-FREEC: a tool for assessing copy number and allelic content using next-generation sequencing data. </a:t>
            </a:r>
            <a:r>
              <a:rPr lang="en-IE" sz="12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ioinformatics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 </a:t>
            </a:r>
            <a:r>
              <a:rPr lang="en-IE" sz="12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8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3), pp.423-425.</a:t>
            </a:r>
            <a:endParaRPr lang="en-IE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  <a:p>
            <a:pPr marL="514350" indent="-514350" algn="just">
              <a:lnSpc>
                <a:spcPct val="200000"/>
              </a:lnSpc>
              <a:buClr>
                <a:srgbClr val="222222"/>
              </a:buClr>
              <a:buSzPts val="1000"/>
              <a:buFont typeface="+mj-lt"/>
              <a:buAutoNum type="arabicPeriod" startAt="17"/>
            </a:pP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jarczyk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A.,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énault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M.,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arsit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S., Charron, G., 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schborn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T., Nicole-</a:t>
            </a:r>
            <a:r>
              <a:rPr lang="en-IE" sz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abrie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L. and Landry, C.R., 2020. The genome sequence of the Jean-Talon strain, an archaeological beer yeast from Québec, reveals traces of adaptation to specific brewing conditions. </a:t>
            </a:r>
            <a:r>
              <a:rPr lang="en-IE" sz="12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3: Genes, Genomes, Genetics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 </a:t>
            </a:r>
            <a:r>
              <a:rPr lang="en-IE" sz="12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0</a:t>
            </a:r>
            <a:r>
              <a:rPr lang="en-IE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9), pp.3087-3097.</a:t>
            </a:r>
            <a:endParaRPr lang="en-IE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  <a:p>
            <a:pPr marL="514350" lvl="0" indent="-514350" algn="just">
              <a:lnSpc>
                <a:spcPct val="200000"/>
              </a:lnSpc>
              <a:buClr>
                <a:srgbClr val="222222"/>
              </a:buClr>
              <a:buSzPts val="1000"/>
              <a:buFont typeface="+mj-lt"/>
              <a:buAutoNum type="arabicPeriod" startAt="17"/>
            </a:pPr>
            <a:endParaRPr lang="en-IE" sz="1200" dirty="0"/>
          </a:p>
        </p:txBody>
      </p:sp>
    </p:spTree>
    <p:extLst>
      <p:ext uri="{BB962C8B-B14F-4D97-AF65-F5344CB8AC3E}">
        <p14:creationId xmlns:p14="http://schemas.microsoft.com/office/powerpoint/2010/main" val="31650386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50</Words>
  <Application>Microsoft Office PowerPoint</Application>
  <PresentationFormat>Widescreen</PresentationFormat>
  <Paragraphs>10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CIDFont+F2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rruish, Daniel W</dc:creator>
  <cp:lastModifiedBy>Daniel Kerruish</cp:lastModifiedBy>
  <cp:revision>14</cp:revision>
  <dcterms:created xsi:type="dcterms:W3CDTF">2023-10-23T13:51:53Z</dcterms:created>
  <dcterms:modified xsi:type="dcterms:W3CDTF">2025-01-17T13:47:4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a7c77bae-9cad-4b1a-aac3-2a4ad557d70b_Enabled">
    <vt:lpwstr>true</vt:lpwstr>
  </property>
  <property fmtid="{D5CDD505-2E9C-101B-9397-08002B2CF9AE}" pid="3" name="MSIP_Label_a7c77bae-9cad-4b1a-aac3-2a4ad557d70b_SetDate">
    <vt:lpwstr>2023-10-23T13:54:49Z</vt:lpwstr>
  </property>
  <property fmtid="{D5CDD505-2E9C-101B-9397-08002B2CF9AE}" pid="4" name="MSIP_Label_a7c77bae-9cad-4b1a-aac3-2a4ad557d70b_Method">
    <vt:lpwstr>Privileged</vt:lpwstr>
  </property>
  <property fmtid="{D5CDD505-2E9C-101B-9397-08002B2CF9AE}" pid="5" name="MSIP_Label_a7c77bae-9cad-4b1a-aac3-2a4ad557d70b_Name">
    <vt:lpwstr>General</vt:lpwstr>
  </property>
  <property fmtid="{D5CDD505-2E9C-101B-9397-08002B2CF9AE}" pid="6" name="MSIP_Label_a7c77bae-9cad-4b1a-aac3-2a4ad557d70b_SiteId">
    <vt:lpwstr>88ed286b-88d8-4faf-918f-883d693321ae</vt:lpwstr>
  </property>
  <property fmtid="{D5CDD505-2E9C-101B-9397-08002B2CF9AE}" pid="7" name="MSIP_Label_a7c77bae-9cad-4b1a-aac3-2a4ad557d70b_ActionId">
    <vt:lpwstr>8b2ebca3-03e9-4ee1-b2b3-16f5f7d2f7dd</vt:lpwstr>
  </property>
  <property fmtid="{D5CDD505-2E9C-101B-9397-08002B2CF9AE}" pid="8" name="MSIP_Label_a7c77bae-9cad-4b1a-aac3-2a4ad557d70b_ContentBits">
    <vt:lpwstr>0</vt:lpwstr>
  </property>
</Properties>
</file>